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83" autoAdjust="0"/>
    <p:restoredTop sz="94660"/>
  </p:normalViewPr>
  <p:slideViewPr>
    <p:cSldViewPr snapToGrid="0">
      <p:cViewPr varScale="1">
        <p:scale>
          <a:sx n="83" d="100"/>
          <a:sy n="83" d="100"/>
        </p:scale>
        <p:origin x="17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935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187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38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309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856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588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858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747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5015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92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61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7D00A-9EE0-4448-B968-D0436F380BA1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EABB0-2F7E-48C6-9065-6A7BECB34C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381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5776BB-698B-B364-7408-90AB541D58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0618" y="945013"/>
            <a:ext cx="4499220" cy="193889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06519" y="182830"/>
            <a:ext cx="2062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. 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15964" y="3276754"/>
            <a:ext cx="5428527" cy="8731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 ACSBG1 protein expression in developing mouse cerebellum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 Samples of cerebellum from w.t. or KO mice of increasing age were subjected to Western blotting as described in Methods. ACSBG1 is detected as a ~7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and. GAPDH was used as a loading control. 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7666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56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Kennedy Krieg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tkins, Paul</dc:creator>
  <cp:lastModifiedBy>Watkins, Paul</cp:lastModifiedBy>
  <cp:revision>1</cp:revision>
  <dcterms:created xsi:type="dcterms:W3CDTF">2024-06-19T17:51:25Z</dcterms:created>
  <dcterms:modified xsi:type="dcterms:W3CDTF">2024-06-19T17:54:26Z</dcterms:modified>
</cp:coreProperties>
</file>